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85"/>
    <p:restoredTop sz="94651"/>
  </p:normalViewPr>
  <p:slideViewPr>
    <p:cSldViewPr snapToGrid="0">
      <p:cViewPr varScale="1">
        <p:scale>
          <a:sx n="115" d="100"/>
          <a:sy n="115" d="100"/>
        </p:scale>
        <p:origin x="6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FBD477-0AD3-EFDE-3B7A-D4AB7A5836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D2CDBB-75A6-8D81-395B-7974F487B8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73402D-0CB0-EEB9-439E-A94FCB17F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AA1EE4-9861-BE6F-C22E-EA2D41D90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60462-B968-9C8A-CB0A-C0E74C618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066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DC1B4-13BC-AE4D-4D11-416DC407B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A53C0D-57FA-8983-77FE-1CA46769C3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74A50D-4BFF-1D9B-9713-F7724DCC6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E7AE1E-BD8C-6348-D280-312279046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6603F-456A-00E4-1CDA-7B5A76FC1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890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7B4566-2D3C-D374-24CC-CF16C7EA19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9A7E85-876E-2476-2461-CC95043A9C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045A49-650B-BBEF-609E-4DAD7C247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3A07F-8075-65D1-CA13-46F9D23C4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FA606B-B766-A0CE-3232-9869D00C7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844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720562-2C5B-3F97-A1A6-0B44F017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CFBC7E-95CD-6F6C-8ABA-97D5B9F23F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49974B-1745-6145-9B34-212951971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0435F0-FD55-F691-1F1C-A80CA4499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81A33B-6921-B0E9-47EB-2B1479417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012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5CCCE-4EC8-0458-F327-F47A671FD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AF3A3A-05A4-7E29-EA07-5B05B6DC1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F2C466-68EE-C895-65F4-D01807A81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CB25C2-0047-2AF2-9EC0-C7C151382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34D02-75C8-8F77-922A-D2D4D6414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064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82C6A-EFD6-2259-E48F-4A9441ADC7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EE3A54-CD8E-0471-B8CF-4ADE5A9B8A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13B7D6-58D9-C3CD-0597-9FB5B186CD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599BA2-361D-F5DF-9704-3E413B58B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50C7A1-705E-4889-109E-517EDCDFA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D55898-37C2-DE7C-1351-F69E15EF3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03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FD8EE-F253-6D03-36FE-AD4BC24BA8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7A1CE4-F8D1-8A71-71B3-BF708F84A6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88FE05-4CDF-462E-5F2D-7256578E7C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D44C68-21A7-7A0E-661E-AE2195A465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A50289-F827-5F79-2FC8-5F887A0DF9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EE7C5A-155B-6DD9-3629-DFC9C154F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B321FC-82C9-8910-C0F2-5407C295D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1BA3E9-2803-EA88-A5C5-6852581F4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28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CB40D-7BE0-9B64-5453-5328BA1F59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C6FFA7-7E46-D4B5-A3B8-9BCC05F0F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57C831-2E71-9341-FF70-3F65C8CC2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9930BE-5524-A62C-9636-F12A34FE6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572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05A20A-174E-8532-8B57-16E866D2A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6382BE-4877-6727-E68F-2835148D0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5FB63E-D14E-B19D-1609-FD57B3C73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65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7F3356-51F8-6207-C0DE-95C07D7CA3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B249FA-CD30-EAAE-AACC-DFB418DF80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FDBC90-507A-C4C7-3E5B-E0CA25BBB9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B39FB3-F8BB-B80F-EAA1-52D1A78F3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01A876-5997-6089-5608-8281B766E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8345AA-4919-280C-DAEA-20FD50442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528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4075F-83A4-25E2-9D2F-15A6E7D26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5083B3-F6E1-3E7E-0A54-71CDE19096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4E2C18-091E-F3B5-26A5-0691931BC0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BBED6B-A183-8678-5EEE-49ACAB38B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BCFD9B-5548-B5BE-ECBD-A248231FE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7E0D58-C676-5E03-BA79-104688D3C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866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DAE2F1-A767-B923-6B4A-32B6DAC618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5E6D97-5E10-9CA4-E3B8-C04383D88D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2962D5-85DF-FC24-7C2C-4F0D69D156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1FE3F5-DD1C-8749-A82E-662A28814026}" type="datetimeFigureOut">
              <a:rPr lang="en-US" smtClean="0"/>
              <a:t>8/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96AADB-2106-8AA6-3B4B-2AD66D02BA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56666D-D719-7601-EC50-9FED3F673C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F9F4B5-CE30-B34D-B446-F2505A9B6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62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BB133ED-5B0F-3A84-3FD9-622823DF4257}"/>
              </a:ext>
            </a:extLst>
          </p:cNvPr>
          <p:cNvSpPr/>
          <p:nvPr/>
        </p:nvSpPr>
        <p:spPr>
          <a:xfrm>
            <a:off x="646671" y="205330"/>
            <a:ext cx="5449329" cy="723952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Unique hospital admissions satisfying inclusion criteria  (n=919,319):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1050" dirty="0"/>
              <a:t>Patient at least 18 years of age;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1050" dirty="0"/>
              <a:t>Clinician provider notes were available for the encounter;</a:t>
            </a:r>
          </a:p>
          <a:p>
            <a:pPr marL="228600" indent="-228600">
              <a:buFont typeface="+mj-lt"/>
              <a:buAutoNum type="arabicPeriod"/>
            </a:pPr>
            <a:r>
              <a:rPr lang="en-US" sz="1050" dirty="0"/>
              <a:t>During the encounter, the patient spent time on a medical-surgical (non-ICU ward)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D8D7A22-E99C-9BD8-5AE9-FF997E0ED406}"/>
              </a:ext>
            </a:extLst>
          </p:cNvPr>
          <p:cNvSpPr/>
          <p:nvPr/>
        </p:nvSpPr>
        <p:spPr>
          <a:xfrm>
            <a:off x="646693" y="1561188"/>
            <a:ext cx="5449307" cy="394000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Encounters with at least one instance of </a:t>
            </a:r>
            <a:r>
              <a:rPr lang="en-US" sz="1050" dirty="0" err="1"/>
              <a:t>eCART</a:t>
            </a:r>
            <a:r>
              <a:rPr lang="en-US" sz="1050" dirty="0"/>
              <a:t> score at or above the 95</a:t>
            </a:r>
            <a:r>
              <a:rPr lang="en-US" sz="1050" baseline="30000" dirty="0"/>
              <a:t>th</a:t>
            </a:r>
            <a:r>
              <a:rPr lang="en-US" sz="1050" dirty="0"/>
              <a:t> percentile (n=91,131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3CDE2482-BABE-AD6D-B84C-BECD2306136F}"/>
              </a:ext>
            </a:extLst>
          </p:cNvPr>
          <p:cNvCxnSpPr>
            <a:cxnSpLocks/>
            <a:stCxn id="4" idx="2"/>
          </p:cNvCxnSpPr>
          <p:nvPr/>
        </p:nvCxnSpPr>
        <p:spPr>
          <a:xfrm>
            <a:off x="3371336" y="929282"/>
            <a:ext cx="0" cy="63190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52CF8A8-13A0-36DF-A2F7-575D36071184}"/>
              </a:ext>
            </a:extLst>
          </p:cNvPr>
          <p:cNvCxnSpPr>
            <a:cxnSpLocks/>
            <a:endCxn id="11" idx="1"/>
          </p:cNvCxnSpPr>
          <p:nvPr/>
        </p:nvCxnSpPr>
        <p:spPr>
          <a:xfrm>
            <a:off x="3371335" y="1245235"/>
            <a:ext cx="300000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3CDD64D4-85F9-CBD2-A6A2-717588BCCFA1}"/>
              </a:ext>
            </a:extLst>
          </p:cNvPr>
          <p:cNvSpPr/>
          <p:nvPr/>
        </p:nvSpPr>
        <p:spPr>
          <a:xfrm>
            <a:off x="6371341" y="1113273"/>
            <a:ext cx="4399107" cy="263923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No instances of </a:t>
            </a:r>
            <a:r>
              <a:rPr lang="en-US" sz="1050" dirty="0" err="1"/>
              <a:t>eCART</a:t>
            </a:r>
            <a:r>
              <a:rPr lang="en-US" sz="1050" dirty="0"/>
              <a:t> score at or above the 95</a:t>
            </a:r>
            <a:r>
              <a:rPr lang="en-US" sz="1050" baseline="30000" dirty="0"/>
              <a:t>th</a:t>
            </a:r>
            <a:r>
              <a:rPr lang="en-US" sz="1050" dirty="0"/>
              <a:t> percentile (n=828,188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A58E555-FC3F-AA74-4D32-C588E5835CC7}"/>
              </a:ext>
            </a:extLst>
          </p:cNvPr>
          <p:cNvSpPr/>
          <p:nvPr/>
        </p:nvSpPr>
        <p:spPr>
          <a:xfrm>
            <a:off x="6371340" y="2155044"/>
            <a:ext cx="2393815" cy="260193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Randomly excluded (n=87,131)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640DEB0-4BC1-0F4F-D47F-EE1679B9701E}"/>
              </a:ext>
            </a:extLst>
          </p:cNvPr>
          <p:cNvSpPr/>
          <p:nvPr/>
        </p:nvSpPr>
        <p:spPr>
          <a:xfrm>
            <a:off x="1335091" y="2616393"/>
            <a:ext cx="4072487" cy="854926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Randomly selected for manual chart review (n=4,000):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UChicago Medicine (n=1,000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Endeavor Health (n=1,000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Loyola University Medical Center (n=1,000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UW Health (n=1,000)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D5BC2F3-5DD9-B4CA-A426-3399D7C9CE15}"/>
              </a:ext>
            </a:extLst>
          </p:cNvPr>
          <p:cNvSpPr/>
          <p:nvPr/>
        </p:nvSpPr>
        <p:spPr>
          <a:xfrm>
            <a:off x="6371340" y="3575948"/>
            <a:ext cx="4583907" cy="412598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No structured EHR data available prior to the first instance of </a:t>
            </a:r>
            <a:r>
              <a:rPr lang="en-US" sz="1050" dirty="0" err="1"/>
              <a:t>eCART</a:t>
            </a:r>
            <a:r>
              <a:rPr lang="en-US" sz="1050" dirty="0"/>
              <a:t> score at or above the 95</a:t>
            </a:r>
            <a:r>
              <a:rPr lang="en-US" sz="1050" baseline="30000" dirty="0"/>
              <a:t>th</a:t>
            </a:r>
            <a:r>
              <a:rPr lang="en-US" sz="1050" dirty="0"/>
              <a:t> percentile (n=5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09AD66A-18D5-4BE1-1B35-168B31AE4C74}"/>
              </a:ext>
            </a:extLst>
          </p:cNvPr>
          <p:cNvSpPr/>
          <p:nvPr/>
        </p:nvSpPr>
        <p:spPr>
          <a:xfrm>
            <a:off x="1335091" y="4105860"/>
            <a:ext cx="4072487" cy="862564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Eligible for feature engineering (n=3,995):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UChicago Medicine (n=1,000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Endeavor Health (n=1,000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Loyola University Medical Center (n=1,000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UW Health (n=995)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AEFA6E76-F65E-BA5F-045B-C0D073D0A420}"/>
              </a:ext>
            </a:extLst>
          </p:cNvPr>
          <p:cNvCxnSpPr>
            <a:cxnSpLocks/>
          </p:cNvCxnSpPr>
          <p:nvPr/>
        </p:nvCxnSpPr>
        <p:spPr>
          <a:xfrm>
            <a:off x="3371335" y="1969188"/>
            <a:ext cx="0" cy="63190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46FE8C2E-6F85-9992-8E79-232054EDC1ED}"/>
              </a:ext>
            </a:extLst>
          </p:cNvPr>
          <p:cNvCxnSpPr>
            <a:cxnSpLocks/>
          </p:cNvCxnSpPr>
          <p:nvPr/>
        </p:nvCxnSpPr>
        <p:spPr>
          <a:xfrm>
            <a:off x="3371334" y="2285141"/>
            <a:ext cx="300000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822C3428-2847-B6EB-A08B-EE8488492867}"/>
              </a:ext>
            </a:extLst>
          </p:cNvPr>
          <p:cNvCxnSpPr>
            <a:cxnSpLocks/>
          </p:cNvCxnSpPr>
          <p:nvPr/>
        </p:nvCxnSpPr>
        <p:spPr>
          <a:xfrm>
            <a:off x="3371335" y="3466294"/>
            <a:ext cx="0" cy="63190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25953346-0D96-391C-F9CD-1674DDFC73C8}"/>
              </a:ext>
            </a:extLst>
          </p:cNvPr>
          <p:cNvCxnSpPr>
            <a:cxnSpLocks/>
          </p:cNvCxnSpPr>
          <p:nvPr/>
        </p:nvCxnSpPr>
        <p:spPr>
          <a:xfrm>
            <a:off x="3371334" y="3782247"/>
            <a:ext cx="300000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Rectangle 36">
            <a:extLst>
              <a:ext uri="{FF2B5EF4-FFF2-40B4-BE49-F238E27FC236}">
                <a16:creationId xmlns:a16="http://schemas.microsoft.com/office/drawing/2014/main" id="{857C71BB-7431-B7DB-867E-A1B445873D03}"/>
              </a:ext>
            </a:extLst>
          </p:cNvPr>
          <p:cNvSpPr/>
          <p:nvPr/>
        </p:nvSpPr>
        <p:spPr>
          <a:xfrm>
            <a:off x="6371340" y="5073054"/>
            <a:ext cx="4870391" cy="412598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Chart review assessed that instance of first </a:t>
            </a:r>
            <a:r>
              <a:rPr lang="en-US" sz="1050" dirty="0" err="1"/>
              <a:t>eCART</a:t>
            </a:r>
            <a:r>
              <a:rPr lang="en-US" sz="1050" dirty="0"/>
              <a:t> score at or above the 95</a:t>
            </a:r>
            <a:r>
              <a:rPr lang="en-US" sz="1050" baseline="30000" dirty="0"/>
              <a:t>th</a:t>
            </a:r>
            <a:r>
              <a:rPr lang="en-US" sz="1050" dirty="0"/>
              <a:t> percentile did not correspond to a legitimate clinical deterioration event (n=1,515)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18DB2C64-843C-A582-0DE8-9741C24180DD}"/>
              </a:ext>
            </a:extLst>
          </p:cNvPr>
          <p:cNvCxnSpPr>
            <a:cxnSpLocks/>
          </p:cNvCxnSpPr>
          <p:nvPr/>
        </p:nvCxnSpPr>
        <p:spPr>
          <a:xfrm>
            <a:off x="3371335" y="4963400"/>
            <a:ext cx="0" cy="63190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4020B81-3638-E6AD-F2C0-A06300F713F7}"/>
              </a:ext>
            </a:extLst>
          </p:cNvPr>
          <p:cNvCxnSpPr>
            <a:cxnSpLocks/>
          </p:cNvCxnSpPr>
          <p:nvPr/>
        </p:nvCxnSpPr>
        <p:spPr>
          <a:xfrm>
            <a:off x="3371334" y="5279353"/>
            <a:ext cx="300000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8EF95FCE-7080-ED05-A6F2-3F40208C74F0}"/>
              </a:ext>
            </a:extLst>
          </p:cNvPr>
          <p:cNvSpPr/>
          <p:nvPr/>
        </p:nvSpPr>
        <p:spPr>
          <a:xfrm>
            <a:off x="970053" y="5602964"/>
            <a:ext cx="4802562" cy="90214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50" dirty="0"/>
              <a:t>Final study cohort (n=2,480), divided into train (n=1,858) and test (n=622) sets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UChicago Medicine (included in training set, n=483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Endeavor Health (included in training set, n=719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Loyola University Medical Center (test set, n=622)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1050" dirty="0"/>
              <a:t>UW Health (included in training set, n=656)</a:t>
            </a:r>
          </a:p>
        </p:txBody>
      </p:sp>
    </p:spTree>
    <p:extLst>
      <p:ext uri="{BB962C8B-B14F-4D97-AF65-F5344CB8AC3E}">
        <p14:creationId xmlns:p14="http://schemas.microsoft.com/office/powerpoint/2010/main" val="1490404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</TotalTime>
  <Words>291</Words>
  <Application>Microsoft Macintosh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RIC PULICK</dc:creator>
  <cp:lastModifiedBy>ERIC PULICK</cp:lastModifiedBy>
  <cp:revision>4</cp:revision>
  <dcterms:created xsi:type="dcterms:W3CDTF">2025-08-03T20:15:15Z</dcterms:created>
  <dcterms:modified xsi:type="dcterms:W3CDTF">2025-08-04T02:32:22Z</dcterms:modified>
</cp:coreProperties>
</file>